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317" r:id="rId2"/>
    <p:sldId id="319" r:id="rId3"/>
    <p:sldId id="322" r:id="rId4"/>
    <p:sldId id="308" r:id="rId5"/>
    <p:sldId id="321" r:id="rId6"/>
    <p:sldId id="320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DFF"/>
    <a:srgbClr val="A8297C"/>
    <a:srgbClr val="EB36AB"/>
    <a:srgbClr val="0DC20C"/>
    <a:srgbClr val="00FF00"/>
    <a:srgbClr val="6F5EC6"/>
    <a:srgbClr val="DDA817"/>
    <a:srgbClr val="007256"/>
    <a:srgbClr val="87BBC8"/>
    <a:srgbClr val="54ACC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17292A2E-F333-43FB-9621-5CBBE7FDCDCB}" styleName="Light Style 2 - Accent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276" autoAdjust="0"/>
    <p:restoredTop sz="86463"/>
  </p:normalViewPr>
  <p:slideViewPr>
    <p:cSldViewPr snapToGrid="0">
      <p:cViewPr>
        <p:scale>
          <a:sx n="215" d="100"/>
          <a:sy n="215" d="100"/>
        </p:scale>
        <p:origin x="592" y="-416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E610A7-F123-4FAE-AE23-138B6F6D1A94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41375D-73E8-48DE-9830-40C1EF925E19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31259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41375D-73E8-48DE-9830-40C1EF925E19}" type="slidenum">
              <a:rPr lang="en-IN" smtClean="0"/>
              <a:pPr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269998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3D3AF96-6F32-0276-7ED9-65E31B1931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8AE4509-AF80-C049-FFD2-066F06ACBBF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0425DA12-77D9-073B-5C84-7A8E30FC25B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EB4971-C206-A3DB-BE75-06E19FF452E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41375D-73E8-48DE-9830-40C1EF925E19}" type="slidenum">
              <a:rPr lang="en-IN" smtClean="0"/>
              <a:pPr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979016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7BC742-44C6-8733-CDCA-7DFB04E935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8C036EF-B103-3374-E517-90DA619EE09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C257D90-9B73-83DA-21B2-66CB35B005D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5BFD36-6A8B-8D46-9937-A6DED84CCA9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41375D-73E8-48DE-9830-40C1EF925E19}" type="slidenum">
              <a:rPr lang="en-IN" smtClean="0"/>
              <a:pPr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018734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41375D-73E8-48DE-9830-40C1EF925E19}" type="slidenum">
              <a:rPr lang="en-IN" smtClean="0"/>
              <a:pPr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47427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6113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58253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5946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1288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70689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10492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3817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7078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61327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284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146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0B944-BB2A-466F-8F51-090E6B880B31}" type="datetimeFigureOut">
              <a:rPr lang="en-IN" smtClean="0"/>
              <a:pPr/>
              <a:t>01/04/2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1A6500-205E-4C57-80E4-EA1CF7605755}" type="slidenum">
              <a:rPr lang="en-IN" smtClean="0"/>
              <a:pPr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38517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3DD7596-E5FE-C7D4-0264-33C2951FAAA1}"/>
              </a:ext>
            </a:extLst>
          </p:cNvPr>
          <p:cNvSpPr txBox="1"/>
          <p:nvPr/>
        </p:nvSpPr>
        <p:spPr>
          <a:xfrm>
            <a:off x="703319" y="5812065"/>
            <a:ext cx="55290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 includes Figures S1-S3, Table-S1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FE2260D-171E-E68D-F238-EA621C417BF5}"/>
              </a:ext>
            </a:extLst>
          </p:cNvPr>
          <p:cNvSpPr txBox="1"/>
          <p:nvPr/>
        </p:nvSpPr>
        <p:spPr>
          <a:xfrm>
            <a:off x="541865" y="1021674"/>
            <a:ext cx="5937957" cy="43396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IN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chromatin reader ZMYND8 recruits the </a:t>
            </a:r>
            <a:r>
              <a:rPr lang="en-IN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uRD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omponent GATAD2A through its MYND domain to regulate MAPT213 long noncoding RNA transcription </a:t>
            </a:r>
            <a:r>
              <a:rPr lang="en-IN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pPr>
              <a:lnSpc>
                <a:spcPct val="200000"/>
              </a:lnSpc>
            </a:pPr>
            <a:endParaRPr lang="en-IN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ushyant Kumar Srivastava</a:t>
            </a:r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andhik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Nandi</a:t>
            </a:r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3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vradeep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Karmakar</a:t>
            </a:r>
            <a:r>
              <a:rPr lang="en-I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4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Chandrima Das</a:t>
            </a:r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 3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Siddhartha Roy</a:t>
            </a:r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4*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/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tructural Biology and Bio-Informatics Division, Council of Scientific &amp; Industrial Research-Indian Institute of Chemical Biology, Kolkata, India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ophysics &amp; Structural Genomics Division, Saha Institute of Nuclear Physics, Kolkata, India</a:t>
            </a: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Homi Bhabha National Institute, Mumbai, India</a:t>
            </a: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ademy of Scientific and Innovative Research (</a:t>
            </a:r>
            <a:r>
              <a:rPr lang="en-IN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cSIR</a:t>
            </a:r>
            <a:r>
              <a:rPr lang="en-I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 Ghaziabad 201002, India</a:t>
            </a:r>
            <a:endParaRPr lang="en-IN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 Correspondence: </a:t>
            </a:r>
            <a:r>
              <a:rPr lang="en-IN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oysiddhartha@iicb.res.in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2711250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A30FFE1-8E76-32C3-2AB7-1A200F07B1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97B4D59-05BF-49F6-497B-5D33C17A0A3D}"/>
              </a:ext>
            </a:extLst>
          </p:cNvPr>
          <p:cNvSpPr txBox="1"/>
          <p:nvPr/>
        </p:nvSpPr>
        <p:spPr>
          <a:xfrm>
            <a:off x="425399" y="3812450"/>
            <a:ext cx="60815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:</a:t>
            </a:r>
            <a:r>
              <a:rPr lang="en-IN" sz="12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analysis of FLAG-tagged ZMYND8 constructs across three independent biological replicates. Whole cell lysates from cells transfected with control vector, FLAG-ZMYND8-FL (full-length), or FLAG-ZMYND8-ΔMYND (MYND domain deletion mutant) were </a:t>
            </a:r>
            <a:r>
              <a:rPr lang="en-IN" sz="12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zed</a:t>
            </a:r>
            <a:r>
              <a:rPr lang="en-I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immunoblotting. Upper panels show anti-FLAG detection of the respective constructs. Lower panels show loading control.</a:t>
            </a:r>
            <a:endParaRPr lang="en-IN" sz="1200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449692E9-7D6F-8FDD-9CE8-9CCD2527A259}"/>
              </a:ext>
            </a:extLst>
          </p:cNvPr>
          <p:cNvGrpSpPr/>
          <p:nvPr/>
        </p:nvGrpSpPr>
        <p:grpSpPr>
          <a:xfrm>
            <a:off x="366150" y="1704420"/>
            <a:ext cx="6333649" cy="2045131"/>
            <a:chOff x="488813" y="1693269"/>
            <a:chExt cx="6333649" cy="2045131"/>
          </a:xfrm>
        </p:grpSpPr>
        <p:grpSp>
          <p:nvGrpSpPr>
            <p:cNvPr id="56" name="Group 55">
              <a:extLst>
                <a:ext uri="{FF2B5EF4-FFF2-40B4-BE49-F238E27FC236}">
                  <a16:creationId xmlns:a16="http://schemas.microsoft.com/office/drawing/2014/main" id="{7FE50FC9-E8A7-65C1-3E84-BF1C77D55AD7}"/>
                </a:ext>
              </a:extLst>
            </p:cNvPr>
            <p:cNvGrpSpPr/>
            <p:nvPr/>
          </p:nvGrpSpPr>
          <p:grpSpPr>
            <a:xfrm>
              <a:off x="488813" y="1693269"/>
              <a:ext cx="1340710" cy="2045131"/>
              <a:chOff x="488813" y="1693269"/>
              <a:chExt cx="1340710" cy="2045131"/>
            </a:xfrm>
          </p:grpSpPr>
          <p:grpSp>
            <p:nvGrpSpPr>
              <p:cNvPr id="97" name="Group 96">
                <a:extLst>
                  <a:ext uri="{FF2B5EF4-FFF2-40B4-BE49-F238E27FC236}">
                    <a16:creationId xmlns:a16="http://schemas.microsoft.com/office/drawing/2014/main" id="{149B734D-A4FF-C7C4-57E7-2948E5DC2234}"/>
                  </a:ext>
                </a:extLst>
              </p:cNvPr>
              <p:cNvGrpSpPr/>
              <p:nvPr/>
            </p:nvGrpSpPr>
            <p:grpSpPr>
              <a:xfrm>
                <a:off x="488813" y="1693269"/>
                <a:ext cx="1340710" cy="1297537"/>
                <a:chOff x="837350" y="6334716"/>
                <a:chExt cx="1340710" cy="1297537"/>
              </a:xfrm>
            </p:grpSpPr>
            <p:pic>
              <p:nvPicPr>
                <p:cNvPr id="105" name="Picture 104">
                  <a:extLst>
                    <a:ext uri="{FF2B5EF4-FFF2-40B4-BE49-F238E27FC236}">
                      <a16:creationId xmlns:a16="http://schemas.microsoft.com/office/drawing/2014/main" id="{175E3AC1-52B5-2040-C592-EAF1137B2B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999" t="50954" r="65222" b="40383"/>
                <a:stretch>
                  <a:fillRect/>
                </a:stretch>
              </p:blipFill>
              <p:spPr>
                <a:xfrm>
                  <a:off x="1170632" y="7194137"/>
                  <a:ext cx="997843" cy="438116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106" name="Straight Connector 105">
                  <a:extLst>
                    <a:ext uri="{FF2B5EF4-FFF2-40B4-BE49-F238E27FC236}">
                      <a16:creationId xmlns:a16="http://schemas.microsoft.com/office/drawing/2014/main" id="{0EA27469-6810-39F1-ED81-82C9779A7E9E}"/>
                    </a:ext>
                  </a:extLst>
                </p:cNvPr>
                <p:cNvCxnSpPr/>
                <p:nvPr/>
              </p:nvCxnSpPr>
              <p:spPr>
                <a:xfrm flipH="1">
                  <a:off x="1105598" y="7285055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3AA9F936-4A66-5045-1A54-6236D922F307}"/>
                    </a:ext>
                  </a:extLst>
                </p:cNvPr>
                <p:cNvSpPr txBox="1"/>
                <p:nvPr/>
              </p:nvSpPr>
              <p:spPr>
                <a:xfrm>
                  <a:off x="838891" y="7179065"/>
                  <a:ext cx="35779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0</a:t>
                  </a:r>
                  <a:endParaRPr lang="en-I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7133AEEB-AC7A-4435-4F28-C124B3D5B575}"/>
                    </a:ext>
                  </a:extLst>
                </p:cNvPr>
                <p:cNvSpPr txBox="1"/>
                <p:nvPr/>
              </p:nvSpPr>
              <p:spPr>
                <a:xfrm>
                  <a:off x="837350" y="7009917"/>
                  <a:ext cx="37382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IN" sz="800" b="1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C29DB410-3716-DAF4-980D-87970BA8DEA0}"/>
                    </a:ext>
                  </a:extLst>
                </p:cNvPr>
                <p:cNvSpPr txBox="1"/>
                <p:nvPr/>
              </p:nvSpPr>
              <p:spPr>
                <a:xfrm rot="16200000">
                  <a:off x="1035944" y="6847622"/>
                  <a:ext cx="60735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I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091B5D3F-5934-B818-60E1-0AA566B7FA5E}"/>
                    </a:ext>
                  </a:extLst>
                </p:cNvPr>
                <p:cNvSpPr txBox="1"/>
                <p:nvPr/>
              </p:nvSpPr>
              <p:spPr>
                <a:xfrm rot="16200000">
                  <a:off x="1192018" y="6726137"/>
                  <a:ext cx="82400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GB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ZMYND8-FL</a:t>
                  </a:r>
                  <a:endParaRPr lang="en-I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504DAE67-1A4D-4EA5-2611-3B5D1B3B725D}"/>
                    </a:ext>
                  </a:extLst>
                </p:cNvPr>
                <p:cNvSpPr txBox="1"/>
                <p:nvPr/>
              </p:nvSpPr>
              <p:spPr>
                <a:xfrm rot="16200000">
                  <a:off x="1542352" y="6631870"/>
                  <a:ext cx="93286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ZMYND8-</a:t>
                  </a:r>
                  <a:r>
                    <a:rPr lang="el-GR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Δ</a:t>
                  </a:r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YND</a:t>
                  </a:r>
                  <a:endParaRPr lang="en-IN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81589C08-BCB4-DD00-DAF4-C5AF1D8123FB}"/>
                  </a:ext>
                </a:extLst>
              </p:cNvPr>
              <p:cNvSpPr txBox="1"/>
              <p:nvPr/>
            </p:nvSpPr>
            <p:spPr>
              <a:xfrm>
                <a:off x="972240" y="3522956"/>
                <a:ext cx="767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 1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9" name="Group 98">
                <a:extLst>
                  <a:ext uri="{FF2B5EF4-FFF2-40B4-BE49-F238E27FC236}">
                    <a16:creationId xmlns:a16="http://schemas.microsoft.com/office/drawing/2014/main" id="{3AF4ACB4-7A25-C305-A040-E6898B5286DB}"/>
                  </a:ext>
                </a:extLst>
              </p:cNvPr>
              <p:cNvGrpSpPr/>
              <p:nvPr/>
            </p:nvGrpSpPr>
            <p:grpSpPr>
              <a:xfrm>
                <a:off x="767970" y="3027203"/>
                <a:ext cx="1054434" cy="526351"/>
                <a:chOff x="1334645" y="3167574"/>
                <a:chExt cx="1093071" cy="561942"/>
              </a:xfrm>
            </p:grpSpPr>
            <p:pic>
              <p:nvPicPr>
                <p:cNvPr id="102" name="Picture 101">
                  <a:extLst>
                    <a:ext uri="{FF2B5EF4-FFF2-40B4-BE49-F238E27FC236}">
                      <a16:creationId xmlns:a16="http://schemas.microsoft.com/office/drawing/2014/main" id="{342943E4-7768-6264-91F2-202D3A41DC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927" t="45848" r="61086" b="43293"/>
                <a:stretch>
                  <a:fillRect/>
                </a:stretch>
              </p:blipFill>
              <p:spPr>
                <a:xfrm>
                  <a:off x="1393310" y="3167574"/>
                  <a:ext cx="1034406" cy="56194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103" name="Straight Connector 102">
                  <a:extLst>
                    <a:ext uri="{FF2B5EF4-FFF2-40B4-BE49-F238E27FC236}">
                      <a16:creationId xmlns:a16="http://schemas.microsoft.com/office/drawing/2014/main" id="{1801C359-6020-B73F-3B96-69E5867FC1F0}"/>
                    </a:ext>
                  </a:extLst>
                </p:cNvPr>
                <p:cNvCxnSpPr/>
                <p:nvPr/>
              </p:nvCxnSpPr>
              <p:spPr>
                <a:xfrm flipH="1">
                  <a:off x="1334647" y="3174950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Straight Connector 103">
                  <a:extLst>
                    <a:ext uri="{FF2B5EF4-FFF2-40B4-BE49-F238E27FC236}">
                      <a16:creationId xmlns:a16="http://schemas.microsoft.com/office/drawing/2014/main" id="{1067E306-144D-5E88-40F1-49067164D0FD}"/>
                    </a:ext>
                  </a:extLst>
                </p:cNvPr>
                <p:cNvCxnSpPr/>
                <p:nvPr/>
              </p:nvCxnSpPr>
              <p:spPr>
                <a:xfrm flipH="1">
                  <a:off x="1334645" y="3714531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07E7AA75-2367-F3CB-ACAF-8D57B080164C}"/>
                  </a:ext>
                </a:extLst>
              </p:cNvPr>
              <p:cNvSpPr txBox="1"/>
              <p:nvPr/>
            </p:nvSpPr>
            <p:spPr>
              <a:xfrm>
                <a:off x="548062" y="29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B7F1E5FF-6739-630C-7F1E-D1644278243B}"/>
                  </a:ext>
                </a:extLst>
              </p:cNvPr>
              <p:cNvSpPr txBox="1"/>
              <p:nvPr/>
            </p:nvSpPr>
            <p:spPr>
              <a:xfrm>
                <a:off x="560424" y="3430533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F174D232-2F62-EA4F-C745-56E7EA17F6B3}"/>
                </a:ext>
              </a:extLst>
            </p:cNvPr>
            <p:cNvGrpSpPr/>
            <p:nvPr/>
          </p:nvGrpSpPr>
          <p:grpSpPr>
            <a:xfrm>
              <a:off x="4624292" y="1693269"/>
              <a:ext cx="1369087" cy="1979148"/>
              <a:chOff x="3203170" y="1702723"/>
              <a:chExt cx="1369087" cy="1979148"/>
            </a:xfrm>
          </p:grpSpPr>
          <p:grpSp>
            <p:nvGrpSpPr>
              <p:cNvPr id="81" name="Group 80">
                <a:extLst>
                  <a:ext uri="{FF2B5EF4-FFF2-40B4-BE49-F238E27FC236}">
                    <a16:creationId xmlns:a16="http://schemas.microsoft.com/office/drawing/2014/main" id="{D2AE2D15-9E8E-0FEE-DE6E-0943A4A87A28}"/>
                  </a:ext>
                </a:extLst>
              </p:cNvPr>
              <p:cNvGrpSpPr/>
              <p:nvPr/>
            </p:nvGrpSpPr>
            <p:grpSpPr>
              <a:xfrm>
                <a:off x="3203170" y="1702723"/>
                <a:ext cx="1369087" cy="1267532"/>
                <a:chOff x="3288315" y="6474214"/>
                <a:chExt cx="1369087" cy="1267532"/>
              </a:xfrm>
            </p:grpSpPr>
            <p:pic>
              <p:nvPicPr>
                <p:cNvPr id="89" name="Picture 88">
                  <a:extLst>
                    <a:ext uri="{FF2B5EF4-FFF2-40B4-BE49-F238E27FC236}">
                      <a16:creationId xmlns:a16="http://schemas.microsoft.com/office/drawing/2014/main" id="{55551FFC-2667-B709-AAE9-C6AF1FE42F3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265" t="50058" r="25525" b="41609"/>
                <a:stretch>
                  <a:fillRect/>
                </a:stretch>
              </p:blipFill>
              <p:spPr>
                <a:xfrm>
                  <a:off x="3625116" y="7348911"/>
                  <a:ext cx="1014524" cy="392835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grpSp>
              <p:nvGrpSpPr>
                <p:cNvPr id="90" name="Group 89">
                  <a:extLst>
                    <a:ext uri="{FF2B5EF4-FFF2-40B4-BE49-F238E27FC236}">
                      <a16:creationId xmlns:a16="http://schemas.microsoft.com/office/drawing/2014/main" id="{13AC97D3-C98D-AAB9-9740-15C6CEF9736A}"/>
                    </a:ext>
                  </a:extLst>
                </p:cNvPr>
                <p:cNvGrpSpPr/>
                <p:nvPr/>
              </p:nvGrpSpPr>
              <p:grpSpPr>
                <a:xfrm>
                  <a:off x="3288315" y="6474214"/>
                  <a:ext cx="1369087" cy="1140475"/>
                  <a:chOff x="808973" y="6334716"/>
                  <a:chExt cx="1369087" cy="1140475"/>
                </a:xfrm>
              </p:grpSpPr>
              <p:cxnSp>
                <p:nvCxnSpPr>
                  <p:cNvPr id="91" name="Straight Connector 90">
                    <a:extLst>
                      <a:ext uri="{FF2B5EF4-FFF2-40B4-BE49-F238E27FC236}">
                        <a16:creationId xmlns:a16="http://schemas.microsoft.com/office/drawing/2014/main" id="{B8E36822-6FB7-A9AE-614D-FA254C15CE1E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084085" y="7360360"/>
                    <a:ext cx="549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90026271-D059-E98E-3D0E-81E16D7852AD}"/>
                      </a:ext>
                    </a:extLst>
                  </p:cNvPr>
                  <p:cNvSpPr txBox="1"/>
                  <p:nvPr/>
                </p:nvSpPr>
                <p:spPr>
                  <a:xfrm>
                    <a:off x="808973" y="7259747"/>
                    <a:ext cx="35779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52372C2C-8652-5E89-D3D6-1757AA6DF85B}"/>
                      </a:ext>
                    </a:extLst>
                  </p:cNvPr>
                  <p:cNvSpPr txBox="1"/>
                  <p:nvPr/>
                </p:nvSpPr>
                <p:spPr>
                  <a:xfrm>
                    <a:off x="837350" y="7009917"/>
                    <a:ext cx="37382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u="sng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IN" sz="800" b="1" u="sng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0E6DAD09-4846-8028-5759-71A5F64D484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043628" y="6855306"/>
                    <a:ext cx="607357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334975E0-DC8B-B2B1-39F7-A7C6FB740AE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92018" y="6748997"/>
                    <a:ext cx="82400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ZMYND8-FL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27FFA4AC-29C2-935F-20F7-B080BF9A079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542352" y="6631870"/>
                    <a:ext cx="93286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ZMYND8-</a:t>
                    </a:r>
                    <a:r>
                      <a:rPr lang="el-GR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YND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7ABB6BCF-E5D1-CBD2-38AC-6B0BD9A6E138}"/>
                  </a:ext>
                </a:extLst>
              </p:cNvPr>
              <p:cNvSpPr txBox="1"/>
              <p:nvPr/>
            </p:nvSpPr>
            <p:spPr>
              <a:xfrm>
                <a:off x="3733063" y="3466427"/>
                <a:ext cx="767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 3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3" name="Group 82">
                <a:extLst>
                  <a:ext uri="{FF2B5EF4-FFF2-40B4-BE49-F238E27FC236}">
                    <a16:creationId xmlns:a16="http://schemas.microsoft.com/office/drawing/2014/main" id="{968C4A8D-74F2-4AEC-7403-171C29915D9F}"/>
                  </a:ext>
                </a:extLst>
              </p:cNvPr>
              <p:cNvGrpSpPr/>
              <p:nvPr/>
            </p:nvGrpSpPr>
            <p:grpSpPr>
              <a:xfrm>
                <a:off x="3478282" y="3015881"/>
                <a:ext cx="1093975" cy="476295"/>
                <a:chOff x="5434753" y="3253432"/>
                <a:chExt cx="1153048" cy="560553"/>
              </a:xfrm>
            </p:grpSpPr>
            <p:pic>
              <p:nvPicPr>
                <p:cNvPr id="86" name="Picture 85">
                  <a:extLst>
                    <a:ext uri="{FF2B5EF4-FFF2-40B4-BE49-F238E27FC236}">
                      <a16:creationId xmlns:a16="http://schemas.microsoft.com/office/drawing/2014/main" id="{C4426525-3894-1CD9-D672-55A90173855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529" t="46138" r="40609" b="43030"/>
                <a:stretch>
                  <a:fillRect/>
                </a:stretch>
              </p:blipFill>
              <p:spPr>
                <a:xfrm>
                  <a:off x="5496790" y="3253432"/>
                  <a:ext cx="1091011" cy="560553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87" name="Straight Connector 86">
                  <a:extLst>
                    <a:ext uri="{FF2B5EF4-FFF2-40B4-BE49-F238E27FC236}">
                      <a16:creationId xmlns:a16="http://schemas.microsoft.com/office/drawing/2014/main" id="{10608B9E-24D4-E6C3-369E-4E3546271A61}"/>
                    </a:ext>
                  </a:extLst>
                </p:cNvPr>
                <p:cNvCxnSpPr/>
                <p:nvPr/>
              </p:nvCxnSpPr>
              <p:spPr>
                <a:xfrm flipH="1">
                  <a:off x="5439957" y="3294439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>
                  <a:extLst>
                    <a:ext uri="{FF2B5EF4-FFF2-40B4-BE49-F238E27FC236}">
                      <a16:creationId xmlns:a16="http://schemas.microsoft.com/office/drawing/2014/main" id="{F576E865-4D64-70BF-0948-ADF2F6D2F6BE}"/>
                    </a:ext>
                  </a:extLst>
                </p:cNvPr>
                <p:cNvCxnSpPr/>
                <p:nvPr/>
              </p:nvCxnSpPr>
              <p:spPr>
                <a:xfrm flipH="1">
                  <a:off x="5434753" y="3813985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7A64DD6-6CE2-5445-025E-88CAAC49FA32}"/>
                  </a:ext>
                </a:extLst>
              </p:cNvPr>
              <p:cNvSpPr txBox="1"/>
              <p:nvPr/>
            </p:nvSpPr>
            <p:spPr>
              <a:xfrm>
                <a:off x="3261240" y="293509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2DA45FE6-7E0C-0CA2-F43C-B2BD0B69672F}"/>
                  </a:ext>
                </a:extLst>
              </p:cNvPr>
              <p:cNvSpPr txBox="1"/>
              <p:nvPr/>
            </p:nvSpPr>
            <p:spPr>
              <a:xfrm>
                <a:off x="3273602" y="33837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5D453650-5663-902C-EC04-1EECF9853CA5}"/>
                </a:ext>
              </a:extLst>
            </p:cNvPr>
            <p:cNvGrpSpPr/>
            <p:nvPr/>
          </p:nvGrpSpPr>
          <p:grpSpPr>
            <a:xfrm>
              <a:off x="2522381" y="1734736"/>
              <a:ext cx="1277072" cy="1982571"/>
              <a:chOff x="1900599" y="1682786"/>
              <a:chExt cx="1277072" cy="1982571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F5DA2E3C-A6D5-87FF-29EB-036A66C8ECCA}"/>
                  </a:ext>
                </a:extLst>
              </p:cNvPr>
              <p:cNvGrpSpPr/>
              <p:nvPr/>
            </p:nvGrpSpPr>
            <p:grpSpPr>
              <a:xfrm>
                <a:off x="1900599" y="1682786"/>
                <a:ext cx="1277072" cy="1266160"/>
                <a:chOff x="3434023" y="6427256"/>
                <a:chExt cx="1277072" cy="1266160"/>
              </a:xfrm>
            </p:grpSpPr>
            <p:pic>
              <p:nvPicPr>
                <p:cNvPr id="73" name="Picture 72">
                  <a:extLst>
                    <a:ext uri="{FF2B5EF4-FFF2-40B4-BE49-F238E27FC236}">
                      <a16:creationId xmlns:a16="http://schemas.microsoft.com/office/drawing/2014/main" id="{4DB1349E-BABA-605C-2964-2721C6A7EB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025" t="50576" r="45774" b="40637"/>
                <a:stretch>
                  <a:fillRect/>
                </a:stretch>
              </p:blipFill>
              <p:spPr>
                <a:xfrm>
                  <a:off x="3773154" y="7297330"/>
                  <a:ext cx="913165" cy="396086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234C5D6C-7139-C4BC-5DFA-C0E08E81BEE8}"/>
                    </a:ext>
                  </a:extLst>
                </p:cNvPr>
                <p:cNvGrpSpPr/>
                <p:nvPr/>
              </p:nvGrpSpPr>
              <p:grpSpPr>
                <a:xfrm>
                  <a:off x="3434023" y="6427256"/>
                  <a:ext cx="1277072" cy="1116439"/>
                  <a:chOff x="835676" y="6278070"/>
                  <a:chExt cx="1277072" cy="1116439"/>
                </a:xfrm>
              </p:grpSpPr>
              <p:cxnSp>
                <p:nvCxnSpPr>
                  <p:cNvPr id="75" name="Straight Connector 74">
                    <a:extLst>
                      <a:ext uri="{FF2B5EF4-FFF2-40B4-BE49-F238E27FC236}">
                        <a16:creationId xmlns:a16="http://schemas.microsoft.com/office/drawing/2014/main" id="{63196D18-AE9E-A7B6-138D-1D30CEF4F2E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110977" y="7285055"/>
                    <a:ext cx="549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6B976AB7-4093-6125-06AD-E2B5E479563D}"/>
                      </a:ext>
                    </a:extLst>
                  </p:cNvPr>
                  <p:cNvSpPr txBox="1"/>
                  <p:nvPr/>
                </p:nvSpPr>
                <p:spPr>
                  <a:xfrm>
                    <a:off x="835676" y="7179065"/>
                    <a:ext cx="37382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16717188-92E8-AF71-562D-B70C00FFAFEA}"/>
                      </a:ext>
                    </a:extLst>
                  </p:cNvPr>
                  <p:cNvSpPr txBox="1"/>
                  <p:nvPr/>
                </p:nvSpPr>
                <p:spPr>
                  <a:xfrm>
                    <a:off x="837350" y="7009917"/>
                    <a:ext cx="37382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u="sng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IN" sz="800" b="1" u="sng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8" name="TextBox 77">
                    <a:extLst>
                      <a:ext uri="{FF2B5EF4-FFF2-40B4-BE49-F238E27FC236}">
                        <a16:creationId xmlns:a16="http://schemas.microsoft.com/office/drawing/2014/main" id="{2C0424BB-D89C-631F-B000-A8335CE3782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023532" y="6803684"/>
                    <a:ext cx="607357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976986B2-9737-6EDC-EB4E-7023F3227D62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61874" y="6685945"/>
                    <a:ext cx="82400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endParaRPr lang="en-GB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ZMYND8-FL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0" name="TextBox 79">
                    <a:extLst>
                      <a:ext uri="{FF2B5EF4-FFF2-40B4-BE49-F238E27FC236}">
                        <a16:creationId xmlns:a16="http://schemas.microsoft.com/office/drawing/2014/main" id="{0301E938-EA0D-EB81-D73F-5510AC8B5B8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477040" y="6575224"/>
                    <a:ext cx="93286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ZMYND8-</a:t>
                    </a:r>
                    <a:r>
                      <a:rPr lang="el-GR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Δ</a:t>
                    </a:r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YND</a:t>
                    </a:r>
                    <a:endParaRPr lang="en-IN" sz="8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5E3DEEF-1892-12AE-866B-96BF7CF8B0CC}"/>
                  </a:ext>
                </a:extLst>
              </p:cNvPr>
              <p:cNvSpPr txBox="1"/>
              <p:nvPr/>
            </p:nvSpPr>
            <p:spPr>
              <a:xfrm>
                <a:off x="2309815" y="3449913"/>
                <a:ext cx="7678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plicate 2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7" name="Group 66">
                <a:extLst>
                  <a:ext uri="{FF2B5EF4-FFF2-40B4-BE49-F238E27FC236}">
                    <a16:creationId xmlns:a16="http://schemas.microsoft.com/office/drawing/2014/main" id="{DB739A47-9B77-0DB0-9DBA-A178AF46308B}"/>
                  </a:ext>
                </a:extLst>
              </p:cNvPr>
              <p:cNvGrpSpPr/>
              <p:nvPr/>
            </p:nvGrpSpPr>
            <p:grpSpPr>
              <a:xfrm>
                <a:off x="2165510" y="2993055"/>
                <a:ext cx="997843" cy="476295"/>
                <a:chOff x="5190570" y="3630679"/>
                <a:chExt cx="1144160" cy="526212"/>
              </a:xfrm>
            </p:grpSpPr>
            <p:pic>
              <p:nvPicPr>
                <p:cNvPr id="70" name="Picture 69">
                  <a:extLst>
                    <a:ext uri="{FF2B5EF4-FFF2-40B4-BE49-F238E27FC236}">
                      <a16:creationId xmlns:a16="http://schemas.microsoft.com/office/drawing/2014/main" id="{8C33959F-0A0F-F6CB-4140-CFFAFAF5ED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702" t="46050" r="20654" b="43782"/>
                <a:stretch>
                  <a:fillRect/>
                </a:stretch>
              </p:blipFill>
              <p:spPr>
                <a:xfrm>
                  <a:off x="5257800" y="3630679"/>
                  <a:ext cx="1076930" cy="526212"/>
                </a:xfrm>
                <a:prstGeom prst="rect">
                  <a:avLst/>
                </a:prstGeom>
                <a:ln w="12700">
                  <a:solidFill>
                    <a:schemeClr val="tx1"/>
                  </a:solidFill>
                </a:ln>
              </p:spPr>
            </p:pic>
            <p:cxnSp>
              <p:nvCxnSpPr>
                <p:cNvPr id="71" name="Straight Connector 70">
                  <a:extLst>
                    <a:ext uri="{FF2B5EF4-FFF2-40B4-BE49-F238E27FC236}">
                      <a16:creationId xmlns:a16="http://schemas.microsoft.com/office/drawing/2014/main" id="{EB95F5B2-5C7F-CDD6-9A41-F2B7B68BEB94}"/>
                    </a:ext>
                  </a:extLst>
                </p:cNvPr>
                <p:cNvCxnSpPr/>
                <p:nvPr/>
              </p:nvCxnSpPr>
              <p:spPr>
                <a:xfrm flipH="1">
                  <a:off x="5190570" y="3663317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2" name="Straight Connector 71">
                  <a:extLst>
                    <a:ext uri="{FF2B5EF4-FFF2-40B4-BE49-F238E27FC236}">
                      <a16:creationId xmlns:a16="http://schemas.microsoft.com/office/drawing/2014/main" id="{C4C76BC4-AA93-2D8F-6D2F-6038F8B82C76}"/>
                    </a:ext>
                  </a:extLst>
                </p:cNvPr>
                <p:cNvCxnSpPr/>
                <p:nvPr/>
              </p:nvCxnSpPr>
              <p:spPr>
                <a:xfrm flipH="1">
                  <a:off x="5195772" y="4156890"/>
                  <a:ext cx="5499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147E7C5F-A5A1-555F-C91D-7F56D405DA96}"/>
                  </a:ext>
                </a:extLst>
              </p:cNvPr>
              <p:cNvSpPr txBox="1"/>
              <p:nvPr/>
            </p:nvSpPr>
            <p:spPr>
              <a:xfrm>
                <a:off x="1953902" y="292856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F73B8E7C-EEE5-9F8B-F555-255D6CB7B14A}"/>
                  </a:ext>
                </a:extLst>
              </p:cNvPr>
              <p:cNvSpPr txBox="1"/>
              <p:nvPr/>
            </p:nvSpPr>
            <p:spPr>
              <a:xfrm>
                <a:off x="1966264" y="336686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I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4BBDB04-F5EB-4BB4-5693-CC71388D7E36}"/>
                </a:ext>
              </a:extLst>
            </p:cNvPr>
            <p:cNvSpPr txBox="1"/>
            <p:nvPr/>
          </p:nvSpPr>
          <p:spPr>
            <a:xfrm>
              <a:off x="1753024" y="2642557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Flag 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41AC531-E6F0-7A15-8A97-8FF4ABFBE927}"/>
                </a:ext>
              </a:extLst>
            </p:cNvPr>
            <p:cNvSpPr txBox="1"/>
            <p:nvPr/>
          </p:nvSpPr>
          <p:spPr>
            <a:xfrm>
              <a:off x="3699427" y="2665968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Flag 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53F6E77-20C1-4311-7206-2358E0D6F747}"/>
                </a:ext>
              </a:extLst>
            </p:cNvPr>
            <p:cNvSpPr txBox="1"/>
            <p:nvPr/>
          </p:nvSpPr>
          <p:spPr>
            <a:xfrm>
              <a:off x="5912830" y="2615034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Flag 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E4E1B2C6-1351-38D9-0FA5-A642FE3A972A}"/>
                </a:ext>
              </a:extLst>
            </p:cNvPr>
            <p:cNvSpPr txBox="1"/>
            <p:nvPr/>
          </p:nvSpPr>
          <p:spPr>
            <a:xfrm>
              <a:off x="1753024" y="3156489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Actin 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F9D78EDA-7386-5726-FBE9-0C63DFE54E02}"/>
                </a:ext>
              </a:extLst>
            </p:cNvPr>
            <p:cNvSpPr txBox="1"/>
            <p:nvPr/>
          </p:nvSpPr>
          <p:spPr>
            <a:xfrm>
              <a:off x="3717246" y="3117295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Actin 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C386505D-61F6-A9F9-6D60-79E8CFE6D890}"/>
                </a:ext>
              </a:extLst>
            </p:cNvPr>
            <p:cNvSpPr txBox="1"/>
            <p:nvPr/>
          </p:nvSpPr>
          <p:spPr>
            <a:xfrm>
              <a:off x="5912830" y="3075637"/>
              <a:ext cx="909632" cy="218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B:Actin </a:t>
              </a:r>
            </a:p>
          </p:txBody>
        </p:sp>
      </p:grpSp>
      <p:sp>
        <p:nvSpPr>
          <p:cNvPr id="113" name="TextBox 112">
            <a:extLst>
              <a:ext uri="{FF2B5EF4-FFF2-40B4-BE49-F238E27FC236}">
                <a16:creationId xmlns:a16="http://schemas.microsoft.com/office/drawing/2014/main" id="{FCD99ADD-6ACC-421E-B336-868F8EFDD2CB}"/>
              </a:ext>
            </a:extLst>
          </p:cNvPr>
          <p:cNvSpPr txBox="1"/>
          <p:nvPr/>
        </p:nvSpPr>
        <p:spPr>
          <a:xfrm>
            <a:off x="2603062" y="756852"/>
            <a:ext cx="13870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4789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F6050B-D13D-B744-D9A6-06CCBDF9155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695D059-92D9-B957-E9EA-47EA23B5B6A1}"/>
              </a:ext>
            </a:extLst>
          </p:cNvPr>
          <p:cNvSpPr txBox="1"/>
          <p:nvPr/>
        </p:nvSpPr>
        <p:spPr>
          <a:xfrm>
            <a:off x="322823" y="5357907"/>
            <a:ext cx="599729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IN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lag </a:t>
            </a:r>
            <a:r>
              <a:rPr lang="en-IN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IP</a:t>
            </a:r>
            <a:r>
              <a:rPr lang="en-IN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Flag-ZMYND8-FL and Flag-ZMYND8-ΔMYND at the Tau (MAPT) promoter as a positive control region (left panel) and MAPT 3’UTR as negative control region (right panel)</a:t>
            </a:r>
            <a:r>
              <a:rPr lang="en-IN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-way ANOVA was performed to </a:t>
            </a:r>
            <a:r>
              <a:rPr lang="en-I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p-value significance (∗p &lt; 0.05; ∗∗p &lt; 0.01; ∗∗∗p &lt; 0.001; ns, nonsignificant (p &gt; 0.05)) for the statistical analyses, the error bar represents the standard deviation (SD), n=3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7D3E19C-121F-8104-39A6-69E625F3CF2B}"/>
              </a:ext>
            </a:extLst>
          </p:cNvPr>
          <p:cNvSpPr txBox="1"/>
          <p:nvPr/>
        </p:nvSpPr>
        <p:spPr>
          <a:xfrm>
            <a:off x="850273" y="4756167"/>
            <a:ext cx="1340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ositive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8835778-E486-2184-8185-FF75D4594324}"/>
              </a:ext>
            </a:extLst>
          </p:cNvPr>
          <p:cNvSpPr txBox="1"/>
          <p:nvPr/>
        </p:nvSpPr>
        <p:spPr>
          <a:xfrm>
            <a:off x="4125525" y="4737487"/>
            <a:ext cx="1433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egative contro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31C869-602D-A9A4-6BC4-CFCC9BC65BEF}"/>
              </a:ext>
            </a:extLst>
          </p:cNvPr>
          <p:cNvSpPr txBox="1"/>
          <p:nvPr/>
        </p:nvSpPr>
        <p:spPr>
          <a:xfrm>
            <a:off x="2656572" y="845564"/>
            <a:ext cx="13298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7700DB3-FC9E-ACF4-D55D-004EB347D4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6144" y="1240096"/>
            <a:ext cx="3213100" cy="349619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8114CBE-0A80-D772-AA0F-C1628B0A15F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48690"/>
          <a:stretch>
            <a:fillRect/>
          </a:stretch>
        </p:blipFill>
        <p:spPr>
          <a:xfrm>
            <a:off x="2388055" y="1362909"/>
            <a:ext cx="4254045" cy="3354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2072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C4151B88-C8D6-51C7-899F-352D73C5D1D4}"/>
              </a:ext>
            </a:extLst>
          </p:cNvPr>
          <p:cNvGrpSpPr/>
          <p:nvPr/>
        </p:nvGrpSpPr>
        <p:grpSpPr>
          <a:xfrm>
            <a:off x="118335" y="3260851"/>
            <a:ext cx="3990066" cy="6461410"/>
            <a:chOff x="2825357" y="3211885"/>
            <a:chExt cx="3990066" cy="646141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A2989BB-4C52-CA4A-AAB4-FBDD17B75C0B}"/>
                </a:ext>
              </a:extLst>
            </p:cNvPr>
            <p:cNvGrpSpPr/>
            <p:nvPr/>
          </p:nvGrpSpPr>
          <p:grpSpPr>
            <a:xfrm>
              <a:off x="2825357" y="3211885"/>
              <a:ext cx="3946907" cy="4249605"/>
              <a:chOff x="2442143" y="5141012"/>
              <a:chExt cx="4125070" cy="4412393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2442143" y="5141012"/>
                <a:ext cx="2693884" cy="4412393"/>
                <a:chOff x="269197" y="343623"/>
                <a:chExt cx="2693884" cy="4412393"/>
              </a:xfrm>
            </p:grpSpPr>
            <p:pic>
              <p:nvPicPr>
                <p:cNvPr id="18" name="Picture 17" descr="Screenshot 2022-03-21 at 5.45.17 PM.png"/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082" t="1590"/>
                <a:stretch/>
              </p:blipFill>
              <p:spPr>
                <a:xfrm>
                  <a:off x="269197" y="343623"/>
                  <a:ext cx="2494323" cy="4412393"/>
                </a:xfrm>
                <a:prstGeom prst="rect">
                  <a:avLst/>
                </a:prstGeom>
              </p:spPr>
            </p:pic>
            <p:sp>
              <p:nvSpPr>
                <p:cNvPr id="10" name="Rectangle 9"/>
                <p:cNvSpPr/>
                <p:nvPr/>
              </p:nvSpPr>
              <p:spPr>
                <a:xfrm>
                  <a:off x="1078821" y="375921"/>
                  <a:ext cx="800779" cy="1706879"/>
                </a:xfrm>
                <a:prstGeom prst="rect">
                  <a:avLst/>
                </a:prstGeom>
                <a:solidFill>
                  <a:schemeClr val="tx1">
                    <a:alpha val="0"/>
                  </a:schemeClr>
                </a:solidFill>
                <a:ln w="19050" cmpd="sng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368280" y="3378668"/>
                  <a:ext cx="655362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solidFill>
                        <a:srgbClr val="FF9494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ain D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1224237" y="3679111"/>
                  <a:ext cx="655362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solidFill>
                        <a:srgbClr val="5A7759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ain C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2096703" y="3359583"/>
                  <a:ext cx="664213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solidFill>
                        <a:srgbClr val="816CF8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ain A 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2298867" y="3808385"/>
                  <a:ext cx="664214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solidFill>
                        <a:srgbClr val="BB9E7A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hain B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535372" y="2421393"/>
                  <a:ext cx="63633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mer-1 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1836656" y="2410294"/>
                  <a:ext cx="63633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imer-2 </a:t>
                  </a:r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5002219" y="5177800"/>
                <a:ext cx="1564994" cy="3048744"/>
                <a:chOff x="4343113" y="309291"/>
                <a:chExt cx="1564994" cy="3048744"/>
              </a:xfrm>
            </p:grpSpPr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4800723" y="3111814"/>
                  <a:ext cx="80069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I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de view</a:t>
                  </a:r>
                </a:p>
              </p:txBody>
            </p:sp>
            <p:pic>
              <p:nvPicPr>
                <p:cNvPr id="3" name="Picture 2" descr="Screenshot 2022-03-21 at 5.34.47 PM.png"/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80"/>
                <a:stretch/>
              </p:blipFill>
              <p:spPr>
                <a:xfrm>
                  <a:off x="4343113" y="309291"/>
                  <a:ext cx="1564994" cy="2718575"/>
                </a:xfrm>
                <a:prstGeom prst="rect">
                  <a:avLst/>
                </a:prstGeom>
              </p:spPr>
            </p:pic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4443663" y="2749983"/>
                  <a:ext cx="3010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5533323" y="2531543"/>
                  <a:ext cx="301057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5192963" y="2727123"/>
                  <a:ext cx="30105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91D1801-D7B4-4BD2-8349-77D4735F1B95}"/>
                    </a:ext>
                  </a:extLst>
                </p:cNvPr>
                <p:cNvSpPr txBox="1"/>
                <p:nvPr/>
              </p:nvSpPr>
              <p:spPr>
                <a:xfrm>
                  <a:off x="4824663" y="2620443"/>
                  <a:ext cx="301057" cy="23967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sp>
            <p:nvSpPr>
              <p:cNvPr id="48" name="Right Arrow 47"/>
              <p:cNvSpPr/>
              <p:nvPr/>
            </p:nvSpPr>
            <p:spPr>
              <a:xfrm>
                <a:off x="4428466" y="6179149"/>
                <a:ext cx="619760" cy="172720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Right Arrow 48"/>
              <p:cNvSpPr/>
              <p:nvPr/>
            </p:nvSpPr>
            <p:spPr>
              <a:xfrm rot="5400000">
                <a:off x="5483812" y="8730349"/>
                <a:ext cx="619760" cy="172720"/>
              </a:xfrm>
              <a:prstGeom prst="rightArrow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6F2134E-662B-9043-8C43-352AC4733942}"/>
                </a:ext>
              </a:extLst>
            </p:cNvPr>
            <p:cNvGrpSpPr/>
            <p:nvPr/>
          </p:nvGrpSpPr>
          <p:grpSpPr>
            <a:xfrm>
              <a:off x="4684717" y="7249495"/>
              <a:ext cx="2130706" cy="2423800"/>
              <a:chOff x="6989793" y="5227234"/>
              <a:chExt cx="2047824" cy="2573784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7628688" y="7554797"/>
                <a:ext cx="8006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p</a:t>
                </a:r>
                <a:r>
                  <a:rPr lang="en-I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view</a:t>
                </a:r>
              </a:p>
            </p:txBody>
          </p:sp>
          <p:pic>
            <p:nvPicPr>
              <p:cNvPr id="55" name="Picture 54" descr="Screenshot 2022-03-23 at 5.59.55 PM.png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96804" y="5227234"/>
                <a:ext cx="1940813" cy="2278846"/>
              </a:xfrm>
              <a:prstGeom prst="rect">
                <a:avLst/>
              </a:prstGeom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6989793" y="6513007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8479794" y="5621658"/>
                <a:ext cx="301057" cy="245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8396172" y="6827185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7492710" y="5785000"/>
                <a:ext cx="301057" cy="2451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D65E873A-CF48-4738-B638-B23ABB98D09B}"/>
              </a:ext>
            </a:extLst>
          </p:cNvPr>
          <p:cNvSpPr txBox="1"/>
          <p:nvPr/>
        </p:nvSpPr>
        <p:spPr>
          <a:xfrm>
            <a:off x="164926" y="71586"/>
            <a:ext cx="3973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1D2CD349-F21A-58B3-C0DD-BEE34F950867}"/>
              </a:ext>
            </a:extLst>
          </p:cNvPr>
          <p:cNvGrpSpPr/>
          <p:nvPr/>
        </p:nvGrpSpPr>
        <p:grpSpPr>
          <a:xfrm>
            <a:off x="146597" y="79711"/>
            <a:ext cx="7162800" cy="3231654"/>
            <a:chOff x="68383" y="66378"/>
            <a:chExt cx="7162800" cy="3231654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870A056-D8E0-F44A-8DDB-012DDA73A43A}"/>
                </a:ext>
              </a:extLst>
            </p:cNvPr>
            <p:cNvSpPr txBox="1"/>
            <p:nvPr/>
          </p:nvSpPr>
          <p:spPr>
            <a:xfrm>
              <a:off x="4223968" y="2903980"/>
              <a:ext cx="39244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Courier"/>
                  <a:cs typeface="Courier"/>
                </a:rPr>
                <a:t>ZN2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76D13AD2-302E-1245-B60E-7C6B94A52A34}"/>
                </a:ext>
              </a:extLst>
            </p:cNvPr>
            <p:cNvGrpSpPr/>
            <p:nvPr/>
          </p:nvGrpSpPr>
          <p:grpSpPr>
            <a:xfrm>
              <a:off x="3001883" y="2747551"/>
              <a:ext cx="2594775" cy="372609"/>
              <a:chOff x="2866411" y="2730617"/>
              <a:chExt cx="2594775" cy="372609"/>
            </a:xfrm>
          </p:grpSpPr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5FE016A0-7DB7-BB47-B016-36C93F40F74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67540" y="2730617"/>
                <a:ext cx="2595" cy="20022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id="{08DED152-0213-1A4B-9287-F567A6941D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06760" y="2745447"/>
                <a:ext cx="0" cy="17753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4A0362CC-8E63-1D40-B9EC-F055D16A30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84166" y="2747774"/>
                <a:ext cx="0" cy="32500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76777194-D2D4-D440-B792-57FBED50B1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11795" y="2745416"/>
                <a:ext cx="0" cy="32735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8948266D-5200-184F-AD7C-593363E801C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2866411" y="2922982"/>
                <a:ext cx="1672314" cy="1450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3DE5FC0E-97DC-294F-A210-3010BE0800F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711795" y="3072775"/>
                <a:ext cx="174939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A59A2E2B-C719-C842-948F-FF3D3012BC6D}"/>
                  </a:ext>
                </a:extLst>
              </p:cNvPr>
              <p:cNvSpPr txBox="1"/>
              <p:nvPr/>
            </p:nvSpPr>
            <p:spPr>
              <a:xfrm>
                <a:off x="3059819" y="2872394"/>
                <a:ext cx="39244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Courier"/>
                    <a:cs typeface="Courier"/>
                  </a:rPr>
                  <a:t>ZN1</a:t>
                </a:r>
              </a:p>
            </p:txBody>
          </p:sp>
        </p:grp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7660AE6-4605-C8E9-42C4-0906EDC46560}"/>
                </a:ext>
              </a:extLst>
            </p:cNvPr>
            <p:cNvCxnSpPr>
              <a:cxnSpLocks/>
            </p:cNvCxnSpPr>
            <p:nvPr/>
          </p:nvCxnSpPr>
          <p:spPr>
            <a:xfrm>
              <a:off x="4388451" y="2785744"/>
              <a:ext cx="0" cy="1558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97C96A68-50A2-CE4C-2C8A-89AF4F342FDA}"/>
                </a:ext>
              </a:extLst>
            </p:cNvPr>
            <p:cNvCxnSpPr>
              <a:cxnSpLocks/>
            </p:cNvCxnSpPr>
            <p:nvPr/>
          </p:nvCxnSpPr>
          <p:spPr>
            <a:xfrm>
              <a:off x="4674197" y="2789552"/>
              <a:ext cx="0" cy="15583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DD0EB345-FC83-DAE0-D099-04F77DA0F7F6}"/>
                </a:ext>
              </a:extLst>
            </p:cNvPr>
            <p:cNvCxnSpPr>
              <a:cxnSpLocks/>
            </p:cNvCxnSpPr>
            <p:nvPr/>
          </p:nvCxnSpPr>
          <p:spPr>
            <a:xfrm>
              <a:off x="5596658" y="2768729"/>
              <a:ext cx="0" cy="325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950F05DF-87A4-FEAB-C0A7-3650BD1A8B42}"/>
                </a:ext>
              </a:extLst>
            </p:cNvPr>
            <p:cNvCxnSpPr>
              <a:cxnSpLocks/>
            </p:cNvCxnSpPr>
            <p:nvPr/>
          </p:nvCxnSpPr>
          <p:spPr>
            <a:xfrm>
              <a:off x="5279827" y="2777415"/>
              <a:ext cx="0" cy="32500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1865105D-8758-7743-8E87-7D22E11B295E}"/>
                </a:ext>
              </a:extLst>
            </p:cNvPr>
            <p:cNvSpPr/>
            <p:nvPr/>
          </p:nvSpPr>
          <p:spPr>
            <a:xfrm>
              <a:off x="3126609" y="366966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B650A9C8-C0AE-724F-A4DE-65F0FBF0F06C}"/>
                </a:ext>
              </a:extLst>
            </p:cNvPr>
            <p:cNvSpPr/>
            <p:nvPr/>
          </p:nvSpPr>
          <p:spPr>
            <a:xfrm>
              <a:off x="2598370" y="368115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BBAFD3BA-940D-7649-AC36-831B0B3675D1}"/>
                </a:ext>
              </a:extLst>
            </p:cNvPr>
            <p:cNvSpPr/>
            <p:nvPr/>
          </p:nvSpPr>
          <p:spPr>
            <a:xfrm>
              <a:off x="3739646" y="368115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EA563152-04A2-0D41-AE34-6348EF927BCA}"/>
                </a:ext>
              </a:extLst>
            </p:cNvPr>
            <p:cNvSpPr/>
            <p:nvPr/>
          </p:nvSpPr>
          <p:spPr>
            <a:xfrm>
              <a:off x="4426525" y="360025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4E524811-2E9A-FE47-970E-6C7D2F8A924F}"/>
                </a:ext>
              </a:extLst>
            </p:cNvPr>
            <p:cNvSpPr/>
            <p:nvPr/>
          </p:nvSpPr>
          <p:spPr>
            <a:xfrm>
              <a:off x="5108310" y="361175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A7CC83E3-7DB7-0D43-B455-65B6CED69ECD}"/>
                </a:ext>
              </a:extLst>
            </p:cNvPr>
            <p:cNvSpPr/>
            <p:nvPr/>
          </p:nvSpPr>
          <p:spPr>
            <a:xfrm>
              <a:off x="5658648" y="344242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173515BC-B071-AF41-BB43-313D69370F6C}"/>
                </a:ext>
              </a:extLst>
            </p:cNvPr>
            <p:cNvSpPr/>
            <p:nvPr/>
          </p:nvSpPr>
          <p:spPr>
            <a:xfrm>
              <a:off x="1838212" y="1718381"/>
              <a:ext cx="79200" cy="1044000"/>
            </a:xfrm>
            <a:prstGeom prst="rect">
              <a:avLst/>
            </a:prstGeom>
            <a:solidFill>
              <a:srgbClr val="DAFFB2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9EF43C19-6E7E-2343-28F6-AD930CC7D089}"/>
                </a:ext>
              </a:extLst>
            </p:cNvPr>
            <p:cNvSpPr/>
            <p:nvPr/>
          </p:nvSpPr>
          <p:spPr>
            <a:xfrm>
              <a:off x="2981112" y="1724729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6A2B9C9B-0240-485A-6104-FD70AB39DF84}"/>
                </a:ext>
              </a:extLst>
            </p:cNvPr>
            <p:cNvSpPr/>
            <p:nvPr/>
          </p:nvSpPr>
          <p:spPr>
            <a:xfrm>
              <a:off x="3210162" y="1718350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32FB75FA-04E3-FAA4-3524-0732226CE325}"/>
                </a:ext>
              </a:extLst>
            </p:cNvPr>
            <p:cNvSpPr/>
            <p:nvPr/>
          </p:nvSpPr>
          <p:spPr>
            <a:xfrm>
              <a:off x="3804516" y="1732683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F18CCAD3-A0F0-575A-1889-F93947193DC5}"/>
                </a:ext>
              </a:extLst>
            </p:cNvPr>
            <p:cNvSpPr/>
            <p:nvPr/>
          </p:nvSpPr>
          <p:spPr>
            <a:xfrm>
              <a:off x="3896621" y="1732033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F66F8A83-F703-10F5-5CE1-B6310A9AC6A1}"/>
                </a:ext>
              </a:extLst>
            </p:cNvPr>
            <p:cNvSpPr/>
            <p:nvPr/>
          </p:nvSpPr>
          <p:spPr>
            <a:xfrm>
              <a:off x="4346467" y="1731155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61A1C5EA-8EFA-BCEA-44C9-F7424559D685}"/>
                </a:ext>
              </a:extLst>
            </p:cNvPr>
            <p:cNvSpPr/>
            <p:nvPr/>
          </p:nvSpPr>
          <p:spPr>
            <a:xfrm>
              <a:off x="4651757" y="1758355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83EE7BFA-EB27-3CFB-A4D9-D7ECFBF93F38}"/>
                </a:ext>
              </a:extLst>
            </p:cNvPr>
            <p:cNvSpPr/>
            <p:nvPr/>
          </p:nvSpPr>
          <p:spPr>
            <a:xfrm>
              <a:off x="5264763" y="1741154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6D7EEB81-A406-7F17-38C5-8F4D808CB53A}"/>
                </a:ext>
              </a:extLst>
            </p:cNvPr>
            <p:cNvSpPr/>
            <p:nvPr/>
          </p:nvSpPr>
          <p:spPr>
            <a:xfrm>
              <a:off x="5570053" y="1727473"/>
              <a:ext cx="79200" cy="1044000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D08B1D30-7244-4346-815F-F51E9612123F}"/>
                </a:ext>
              </a:extLst>
            </p:cNvPr>
            <p:cNvSpPr txBox="1"/>
            <p:nvPr/>
          </p:nvSpPr>
          <p:spPr>
            <a:xfrm>
              <a:off x="68383" y="66378"/>
              <a:ext cx="7162800" cy="32316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rtl="0">
                <a:spcBef>
                  <a:spcPts val="0"/>
                </a:spcBef>
                <a:spcAft>
                  <a:spcPts val="0"/>
                </a:spcAft>
              </a:pPr>
              <a:br>
                <a:rPr lang="en-US" sz="800" b="0" dirty="0">
                  <a:effectLst/>
                  <a:latin typeface="Courier New"/>
                  <a:cs typeface="Courier New"/>
                </a:rPr>
              </a:br>
              <a:br>
                <a:rPr lang="en-US" sz="800" b="0" dirty="0">
                  <a:effectLst/>
                  <a:latin typeface="Courier New"/>
                  <a:cs typeface="Courier New"/>
                </a:rPr>
              </a:b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.sapien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          NTTGS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EMK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D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AEVKKQ 1010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.novergicu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NTTGS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EMK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D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AEVKKQ 1020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.musculu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  NTTGS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EMK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D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AEVKKQ 1046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G.gallu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    NTTGS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EMK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D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AEVKKQ 1044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X.laevi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    NTTGS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EME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D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AEVKKQ 1056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.rerio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            STSGNTIAEIR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IEIEK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WLHQQ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EMKH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TMAEMRQ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RE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VAEVKKQ 1088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.melanogaster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GDQSVLQARIAG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LENE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QHYDRQ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NDLHRT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ISEMRKT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QEHKR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V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SELRQQ 1381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                   .  .   *.*  * :* *:*:  ::::: ::.:. ** ::***::****:.*: :*:::*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br>
                <a:rPr lang="en-US" sz="1000" b="0" dirty="0">
                  <a:effectLst/>
                  <a:latin typeface="Courier New"/>
                  <a:cs typeface="Courier New"/>
                </a:rPr>
              </a:b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.sapien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  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062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.novergicu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072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.musculu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1098</a:t>
              </a:r>
              <a:endParaRPr lang="en-US" sz="100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G.gallu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096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X.laevis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L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K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108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.rerio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      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KQQAVDETKK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RKEAIF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AHWPE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KS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140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1" i="0" u="none" strike="noStrike" dirty="0" err="1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.melanogaster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     </a:t>
              </a:r>
              <a:r>
                <a:rPr lang="en-US" sz="100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N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I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ELMRAVEEAKRKQW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AN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MREAQL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WNTSY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DYP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QQLHWPG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H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SAT</a:t>
              </a:r>
              <a:r>
                <a:rPr lang="en-US" sz="1000" b="1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C</a:t>
              </a: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 1433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pPr rtl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b="0" i="0" u="none" strike="noStrike" dirty="0">
                  <a:solidFill>
                    <a:srgbClr val="000000"/>
                  </a:solidFill>
                  <a:effectLst/>
                  <a:latin typeface="Courier New"/>
                  <a:cs typeface="Courier New"/>
                </a:rPr>
                <a:t>                      :*  :**:*:*:******* :** :*************** *** *  :*</a:t>
              </a:r>
              <a:endParaRPr lang="en-US" sz="1000" b="0" dirty="0">
                <a:effectLst/>
                <a:latin typeface="Courier New"/>
                <a:cs typeface="Courier New"/>
              </a:endParaRPr>
            </a:p>
            <a:p>
              <a:br>
                <a:rPr lang="en-US" sz="900" b="0" dirty="0">
                  <a:effectLst/>
                  <a:latin typeface="Courier New"/>
                  <a:cs typeface="Courier New"/>
                </a:rPr>
              </a:br>
              <a:endParaRPr lang="en-US" sz="900" dirty="0">
                <a:latin typeface="Courier New"/>
                <a:cs typeface="Courier New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5159A14D-8750-6E0F-61B9-2CF950C5047D}"/>
              </a:ext>
            </a:extLst>
          </p:cNvPr>
          <p:cNvSpPr txBox="1"/>
          <p:nvPr/>
        </p:nvSpPr>
        <p:spPr>
          <a:xfrm>
            <a:off x="228335" y="3158742"/>
            <a:ext cx="3928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BE7099E-8723-FB8F-8930-8B08F0F3704F}"/>
              </a:ext>
            </a:extLst>
          </p:cNvPr>
          <p:cNvGrpSpPr/>
          <p:nvPr/>
        </p:nvGrpSpPr>
        <p:grpSpPr>
          <a:xfrm>
            <a:off x="4097922" y="3261229"/>
            <a:ext cx="2524003" cy="4582482"/>
            <a:chOff x="214857" y="3242991"/>
            <a:chExt cx="2524003" cy="458248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FB7DD5E-268A-AA42-B0C6-06AF4311209A}"/>
                </a:ext>
              </a:extLst>
            </p:cNvPr>
            <p:cNvGrpSpPr/>
            <p:nvPr/>
          </p:nvGrpSpPr>
          <p:grpSpPr>
            <a:xfrm>
              <a:off x="214857" y="3242991"/>
              <a:ext cx="2524003" cy="4582482"/>
              <a:chOff x="78913" y="5023154"/>
              <a:chExt cx="2552527" cy="4693741"/>
            </a:xfrm>
          </p:grpSpPr>
          <p:pic>
            <p:nvPicPr>
              <p:cNvPr id="2" name="Picture 1" descr="Screenshot 2022-03-22 at 2.33.04 PM.png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97" b="1"/>
              <a:stretch/>
            </p:blipFill>
            <p:spPr>
              <a:xfrm>
                <a:off x="78913" y="5148780"/>
                <a:ext cx="2552527" cy="4408268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649663" y="593006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70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786063" y="591990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70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816543" y="630598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78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639503" y="628566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78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619183" y="670222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85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816543" y="669206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85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619183" y="725086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96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796223" y="7220383"/>
                <a:ext cx="4534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996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629343" y="7636943"/>
                <a:ext cx="53473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1003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704783" y="7616623"/>
                <a:ext cx="53473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1003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2076383" y="9455583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430463" y="9486063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653983" y="5035983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91D1801-D7B4-4BD2-8349-77D4735F1B95}"/>
                  </a:ext>
                </a:extLst>
              </p:cNvPr>
              <p:cNvSpPr txBox="1"/>
              <p:nvPr/>
            </p:nvSpPr>
            <p:spPr>
              <a:xfrm>
                <a:off x="1802063" y="5046143"/>
                <a:ext cx="3010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D65E873A-CF48-4738-B638-B23ABB98D09B}"/>
                  </a:ext>
                </a:extLst>
              </p:cNvPr>
              <p:cNvSpPr txBox="1"/>
              <p:nvPr/>
            </p:nvSpPr>
            <p:spPr>
              <a:xfrm>
                <a:off x="93783" y="5023154"/>
                <a:ext cx="397336" cy="2521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E5B1058-C207-C5EB-AD4A-95FA02CC1A61}"/>
                </a:ext>
              </a:extLst>
            </p:cNvPr>
            <p:cNvSpPr txBox="1"/>
            <p:nvPr/>
          </p:nvSpPr>
          <p:spPr>
            <a:xfrm>
              <a:off x="610622" y="6339628"/>
              <a:ext cx="6270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hain B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7BC4232-DECC-A126-5612-C0AA42613671}"/>
                </a:ext>
              </a:extLst>
            </p:cNvPr>
            <p:cNvSpPr txBox="1"/>
            <p:nvPr/>
          </p:nvSpPr>
          <p:spPr>
            <a:xfrm>
              <a:off x="1811334" y="6302924"/>
              <a:ext cx="6270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hain C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CCE98567-A880-26CA-2FAF-2E4EADE531E0}"/>
              </a:ext>
            </a:extLst>
          </p:cNvPr>
          <p:cNvSpPr txBox="1"/>
          <p:nvPr/>
        </p:nvSpPr>
        <p:spPr>
          <a:xfrm>
            <a:off x="2563388" y="-21224"/>
            <a:ext cx="13298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8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8593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7CCD07A-D015-9742-34E5-F16682060FC2}"/>
              </a:ext>
            </a:extLst>
          </p:cNvPr>
          <p:cNvSpPr txBox="1"/>
          <p:nvPr/>
        </p:nvSpPr>
        <p:spPr>
          <a:xfrm>
            <a:off x="114300" y="440158"/>
            <a:ext cx="6629400" cy="22159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IN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ZMYND8 CC-MYND domain exists as a tetramer in the crystallographic asymmetric unit:</a:t>
            </a:r>
            <a:r>
              <a:rPr lang="en-IN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 Sequence alignment of ZMYND8 coiled-coil MYND domain (CC-MYND) containing protein sequences from multiple organisms across animal phyla. Zinc-coordinating cysteine and histidine residues are highlighted in yellow, demonstrating high evolutionary conservation. Consensus symbols: (*) identical residues, (:) highly similar residues, (.) similar residues. (B) Cartoon representation shows two dimers of ZMYND CC-MYND domain associate in the asymmetric unit forming a four helix bundle structure (shown in side and top view) via their coiled coil stretch. (C) Structure showing leucine-leucine contact at positions as shown in the figure along the interface formed by chain B and C from ZMYND8 CC-MYND Dimer-1 and Dimer-2 respectively.  </a:t>
            </a:r>
            <a:endParaRPr lang="en-IN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84879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CA93202D-3DEB-0275-335E-AF560EF0E9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050" y="3879850"/>
            <a:ext cx="6057900" cy="21463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8F31968-7062-C0E2-54FE-143919597788}"/>
              </a:ext>
            </a:extLst>
          </p:cNvPr>
          <p:cNvSpPr txBox="1"/>
          <p:nvPr/>
        </p:nvSpPr>
        <p:spPr>
          <a:xfrm>
            <a:off x="472612" y="4136704"/>
            <a:ext cx="3256907" cy="286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IN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imers Used for </a:t>
            </a:r>
            <a:r>
              <a:rPr lang="en-IN" sz="12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qRT</a:t>
            </a:r>
            <a:r>
              <a:rPr lang="en-IN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-PCR and </a:t>
            </a:r>
            <a:r>
              <a:rPr lang="en-IN" sz="1200" b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ChIP</a:t>
            </a:r>
            <a:r>
              <a:rPr lang="en-IN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DBFCAC-B2F6-B1F2-9BB8-6AD614901990}"/>
              </a:ext>
            </a:extLst>
          </p:cNvPr>
          <p:cNvSpPr txBox="1"/>
          <p:nvPr/>
        </p:nvSpPr>
        <p:spPr>
          <a:xfrm>
            <a:off x="2833955" y="3593233"/>
            <a:ext cx="895564" cy="286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IN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able S1:</a:t>
            </a:r>
          </a:p>
        </p:txBody>
      </p:sp>
    </p:spTree>
    <p:extLst>
      <p:ext uri="{BB962C8B-B14F-4D97-AF65-F5344CB8AC3E}">
        <p14:creationId xmlns:p14="http://schemas.microsoft.com/office/powerpoint/2010/main" val="1320281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028</TotalTime>
  <Words>624</Words>
  <Application>Microsoft Macintosh PowerPoint</Application>
  <PresentationFormat>A4 Paper (210x297 mm)</PresentationFormat>
  <Paragraphs>117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Courier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jini Dhang</dc:creator>
  <cp:lastModifiedBy>Siddhartha roy</cp:lastModifiedBy>
  <cp:revision>363</cp:revision>
  <dcterms:created xsi:type="dcterms:W3CDTF">2020-04-20T12:07:59Z</dcterms:created>
  <dcterms:modified xsi:type="dcterms:W3CDTF">2026-04-01T06:37:38Z</dcterms:modified>
</cp:coreProperties>
</file>